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71C1D2-66ED-4871-9F61-E29E322CCE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6B5DC49-6B5B-4985-BBB5-79406F88F40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D20A8C-593F-4517-904C-550E37440F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E3F32-DBBD-4175-92AA-4AD5872F87DD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2CFF69-A71E-4198-8733-6273B5B9B4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527359-4712-4EC2-B52D-085893D2BD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3248A-E5FB-4617-A39F-7515A006B9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147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BF9D6C-8B73-4545-9E71-489FF2F298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8D9987-148C-4DA7-B5FF-FA43EE9B4A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B32A77-8252-483B-81E4-1A6FE7BBC9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E3F32-DBBD-4175-92AA-4AD5872F87DD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72837F-5668-4002-ACF7-9AE68E394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493430-BC81-4538-BABB-18616E46B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3248A-E5FB-4617-A39F-7515A006B9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7124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324E6A1-9A19-4ECC-8C5E-82295609E7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1B1A49-489F-4838-AF53-F575304C04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B7A810-966C-4E30-86D7-90C74A7719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E3F32-DBBD-4175-92AA-4AD5872F87DD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55ECFA-563D-44A5-9B0F-E8A79A769A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914A71-E840-44CA-8186-5B1822BDE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3248A-E5FB-4617-A39F-7515A006B9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7609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25528D-584E-4C75-9985-3EFAD07952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B1C7A6-4A77-487F-84EB-77AB7EC824B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C9CD0A-06E7-44E3-A168-56D3606907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E3F32-DBBD-4175-92AA-4AD5872F87DD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0DB3B3-71E7-46F9-99BF-49078FADC4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A2113D-184A-44FA-8354-C218136355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3248A-E5FB-4617-A39F-7515A006B9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59665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B92E39-12A5-42E9-808B-63F51F28DF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DEF822-CC79-4DBF-9FDE-196C701341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AF8007-4A5C-469A-A81B-9481FB04BA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E3F32-DBBD-4175-92AA-4AD5872F87DD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33E04C-4F30-469E-8F08-A72B2E69D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83194C-2CB3-4118-B6AB-DA317BD3BF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3248A-E5FB-4617-A39F-7515A006B9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340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F3A420-E262-49E7-8860-3ABE2D99B3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D6A0F7-1E1D-48E0-958E-F095A91990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D2F903B-BE12-410E-8DF1-69EB583422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82D8ED-B4C6-4D57-B268-D85648E1E4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E3F32-DBBD-4175-92AA-4AD5872F87DD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E975AE-54F6-49C1-A68F-D63CFEF0CC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8D7E63-8417-46F7-BAA5-05341280EF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3248A-E5FB-4617-A39F-7515A006B9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4758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B117F0-C58B-47FC-A9BB-1AC49A49A9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A32E55-6A54-49CB-8D86-1EB6B4C279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2405710-6A70-4601-A954-E6D32D91C3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605C090-0DAA-471B-8959-5660EC73B3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73ADAA4-25D3-4E21-AB5F-DF15E5A637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CE1ED90-73E0-4669-8443-41E07C2EB5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E3F32-DBBD-4175-92AA-4AD5872F87DD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7A0976C-2BB2-4EEA-9E51-3EF8A2155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25189DD-FFA1-4ECB-9B8C-69A5D287D9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3248A-E5FB-4617-A39F-7515A006B9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8980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915620-A3BF-4022-A992-71B1BCA136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53A3225-D1BF-4B6A-870C-7BB72F51CD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E3F32-DBBD-4175-92AA-4AD5872F87DD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2B6C874-83E2-46F7-A764-CB1001227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9E76B0B-EE3C-4779-B16E-A84C5F46FE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3248A-E5FB-4617-A39F-7515A006B9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093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897A5FE-3C63-4109-8E70-6331642E2B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E3F32-DBBD-4175-92AA-4AD5872F87DD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5107483-C2D7-4DA7-AB7A-DAAF245E5B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DD321BE-257C-4E6D-B988-7F7229C0CC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3248A-E5FB-4617-A39F-7515A006B9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444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DF7504-DA30-4F32-9A2F-D9755190BD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D62356-6433-4006-9979-FCFAA7AAB9D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8B7160-5BAE-4729-84E4-307036765F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8729DE-7970-4F8A-8F54-E340879404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E3F32-DBBD-4175-92AA-4AD5872F87DD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401878-7D46-4000-BCC3-503191113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ABEE77-DD23-4147-B747-208322256A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3248A-E5FB-4617-A39F-7515A006B9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4767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81C025-F53D-4D7B-BC7B-0AEE1BA6DF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ECFC2BB-3107-4AF2-90FD-C9D5E06F3E1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606E20D-796F-407C-88B0-F9901D5169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DE16D5-2321-420B-BB93-7AE6CE181C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E3F32-DBBD-4175-92AA-4AD5872F87DD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E43F41-146B-426B-82E7-0896AC8F2C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9B49B5-1FE0-4907-B856-86CE874F3A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3248A-E5FB-4617-A39F-7515A006B9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1984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00F1F74-6F33-4754-99DA-80D2B7F312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953212-69A4-4A36-AF30-7B89CA5D7E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487BAC-1A3C-484E-8FE8-724C8F94F02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DE3F32-DBBD-4175-92AA-4AD5872F87DD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1181ED-6AE7-466A-8442-1B4056522A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49477F-399C-4DB1-B3C3-FDB00856B2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13248A-E5FB-4617-A39F-7515A006B9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9289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2AEC585-985B-44F0-9B49-5111B87B957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90" t="1551" r="35558" b="60506"/>
          <a:stretch/>
        </p:blipFill>
        <p:spPr>
          <a:xfrm>
            <a:off x="456476" y="383037"/>
            <a:ext cx="4970627" cy="175648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F032F65-D595-4FF0-86EC-703F80DF8F5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58" t="71769" b="2"/>
          <a:stretch/>
        </p:blipFill>
        <p:spPr>
          <a:xfrm>
            <a:off x="5628551" y="433972"/>
            <a:ext cx="6563449" cy="175647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86254CA-E133-403A-9060-84498A400C4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84" r="48146" b="67726"/>
          <a:stretch/>
        </p:blipFill>
        <p:spPr>
          <a:xfrm>
            <a:off x="409574" y="2269705"/>
            <a:ext cx="5008728" cy="174561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32E8580-752C-4185-ADEF-B5955B6CEB2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7303" r="296" b="-447"/>
          <a:stretch/>
        </p:blipFill>
        <p:spPr>
          <a:xfrm>
            <a:off x="5619750" y="2298280"/>
            <a:ext cx="6572250" cy="181208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E219B63-886C-4A36-B454-D614750CA21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511" r="45327" b="60601"/>
          <a:stretch/>
        </p:blipFill>
        <p:spPr>
          <a:xfrm>
            <a:off x="409573" y="4253960"/>
            <a:ext cx="5008727" cy="196928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70B5CEA-52AC-4029-BA48-5AAD8F9F0B1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51112" r="-145" b="-218"/>
          <a:stretch/>
        </p:blipFill>
        <p:spPr>
          <a:xfrm>
            <a:off x="5619750" y="4316752"/>
            <a:ext cx="6572250" cy="1906492"/>
          </a:xfrm>
          <a:prstGeom prst="rect">
            <a:avLst/>
          </a:prstGeom>
        </p:spPr>
      </p:pic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29FF8A68-31E8-47CF-A5AA-1743549BABE2}"/>
              </a:ext>
            </a:extLst>
          </p:cNvPr>
          <p:cNvCxnSpPr>
            <a:cxnSpLocks/>
          </p:cNvCxnSpPr>
          <p:nvPr/>
        </p:nvCxnSpPr>
        <p:spPr>
          <a:xfrm>
            <a:off x="0" y="2193028"/>
            <a:ext cx="12192000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EFFE1417-DD31-4AEC-986E-C696B1870919}"/>
              </a:ext>
            </a:extLst>
          </p:cNvPr>
          <p:cNvCxnSpPr>
            <a:cxnSpLocks/>
          </p:cNvCxnSpPr>
          <p:nvPr/>
        </p:nvCxnSpPr>
        <p:spPr>
          <a:xfrm>
            <a:off x="0" y="4148316"/>
            <a:ext cx="12192000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AAC83C5A-AE3F-4424-8F18-ECB9978A229E}"/>
              </a:ext>
            </a:extLst>
          </p:cNvPr>
          <p:cNvSpPr txBox="1"/>
          <p:nvPr/>
        </p:nvSpPr>
        <p:spPr>
          <a:xfrm>
            <a:off x="8802" y="388253"/>
            <a:ext cx="2462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A3A9612-2922-4F69-8653-460A5C1E6894}"/>
              </a:ext>
            </a:extLst>
          </p:cNvPr>
          <p:cNvSpPr txBox="1"/>
          <p:nvPr/>
        </p:nvSpPr>
        <p:spPr>
          <a:xfrm>
            <a:off x="0" y="4220052"/>
            <a:ext cx="2462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0D2058D-AA86-4C2E-9084-503BEE25A56A}"/>
              </a:ext>
            </a:extLst>
          </p:cNvPr>
          <p:cNvSpPr txBox="1"/>
          <p:nvPr/>
        </p:nvSpPr>
        <p:spPr>
          <a:xfrm>
            <a:off x="0" y="2220869"/>
            <a:ext cx="2462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82BD11C-C1D4-494B-9337-3DB583CADCE7}"/>
              </a:ext>
            </a:extLst>
          </p:cNvPr>
          <p:cNvSpPr txBox="1"/>
          <p:nvPr/>
        </p:nvSpPr>
        <p:spPr>
          <a:xfrm>
            <a:off x="114311" y="6503467"/>
            <a:ext cx="124919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l Figure I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| Exported annotated targeted MS2 spectra from Proteome Discoverer 2.1. Spectra are the source data for Figure 4. A, ENO2; B, GFAP; C, TUJ1/TUBB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EDAFADC-AB34-4B01-93EE-17165BE01170}"/>
              </a:ext>
            </a:extLst>
          </p:cNvPr>
          <p:cNvSpPr txBox="1"/>
          <p:nvPr/>
        </p:nvSpPr>
        <p:spPr>
          <a:xfrm>
            <a:off x="5977134" y="388723"/>
            <a:ext cx="12847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ENO2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76FFE4F-FF11-49DE-9A9F-4CA87E04D806}"/>
              </a:ext>
            </a:extLst>
          </p:cNvPr>
          <p:cNvSpPr txBox="1"/>
          <p:nvPr/>
        </p:nvSpPr>
        <p:spPr>
          <a:xfrm>
            <a:off x="5977133" y="2260781"/>
            <a:ext cx="12847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8BFF253-29A5-4E03-B7EE-B1ED3902C0D4}"/>
              </a:ext>
            </a:extLst>
          </p:cNvPr>
          <p:cNvSpPr txBox="1"/>
          <p:nvPr/>
        </p:nvSpPr>
        <p:spPr>
          <a:xfrm>
            <a:off x="5977132" y="4250830"/>
            <a:ext cx="15688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TUJ1/TUBB3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28667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16200000">
            <a:off x="6008797" y="502239"/>
            <a:ext cx="5303520" cy="530352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lum bright="-1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10" t="36980" r="-1" b="11196"/>
          <a:stretch/>
        </p:blipFill>
        <p:spPr>
          <a:xfrm>
            <a:off x="1371599" y="2015299"/>
            <a:ext cx="3770165" cy="355408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 cstate="print">
            <a:lum contrast="2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293408" y="546573"/>
            <a:ext cx="2500946" cy="2482529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sp>
        <p:nvSpPr>
          <p:cNvPr id="7" name="Rectangle 6"/>
          <p:cNvSpPr/>
          <p:nvPr/>
        </p:nvSpPr>
        <p:spPr>
          <a:xfrm>
            <a:off x="1705989" y="2261278"/>
            <a:ext cx="630859" cy="67180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8" name="Straight Connector 7"/>
          <p:cNvCxnSpPr/>
          <p:nvPr/>
        </p:nvCxnSpPr>
        <p:spPr>
          <a:xfrm flipV="1">
            <a:off x="2336848" y="537055"/>
            <a:ext cx="956560" cy="172422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2254924" y="2931633"/>
            <a:ext cx="1038484" cy="10698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5" cstate="print">
            <a:lum bright="-1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143283" y="3266081"/>
            <a:ext cx="2500946" cy="2482529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sp>
        <p:nvSpPr>
          <p:cNvPr id="11" name="Rectangle 10"/>
          <p:cNvSpPr/>
          <p:nvPr/>
        </p:nvSpPr>
        <p:spPr>
          <a:xfrm>
            <a:off x="2403757" y="4601667"/>
            <a:ext cx="630859" cy="67180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2" name="Straight Connector 11"/>
          <p:cNvCxnSpPr/>
          <p:nvPr/>
        </p:nvCxnSpPr>
        <p:spPr>
          <a:xfrm flipV="1">
            <a:off x="3034616" y="3266081"/>
            <a:ext cx="108667" cy="136453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 flipH="1" flipV="1">
            <a:off x="3034616" y="5273472"/>
            <a:ext cx="108668" cy="47513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328549" y="56387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6095797" y="54657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867DE9E-0314-4D08-AA51-B2A07ACEE123}"/>
              </a:ext>
            </a:extLst>
          </p:cNvPr>
          <p:cNvSpPr txBox="1"/>
          <p:nvPr/>
        </p:nvSpPr>
        <p:spPr>
          <a:xfrm>
            <a:off x="114311" y="6037831"/>
            <a:ext cx="120776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l Figure II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| A) Immunohistochemistry shows the presence of DCT in a human aortic valve leaflet. B) Immunofluorescence of DCT (red) shows a similar pattern as that observed for glial (spongiosa) and neuronal (ventricularis) phenotypes and colocalization with the non-selective neural marker AP-2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green). Cell nuclei are shown by DAPI staining (blue).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EF5F034E-2096-4C7E-A1F1-6CD80D2B6D2B}"/>
              </a:ext>
            </a:extLst>
          </p:cNvPr>
          <p:cNvCxnSpPr/>
          <p:nvPr/>
        </p:nvCxnSpPr>
        <p:spPr>
          <a:xfrm>
            <a:off x="5141764" y="5624606"/>
            <a:ext cx="438912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48D2B0B6-B498-4D4A-AF6F-E82422B0D595}"/>
              </a:ext>
            </a:extLst>
          </p:cNvPr>
          <p:cNvCxnSpPr>
            <a:cxnSpLocks/>
          </p:cNvCxnSpPr>
          <p:nvPr/>
        </p:nvCxnSpPr>
        <p:spPr>
          <a:xfrm>
            <a:off x="5205317" y="2931633"/>
            <a:ext cx="438912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9056689A-DFF5-4208-B76A-94D7BF7A1CF1}"/>
              </a:ext>
            </a:extLst>
          </p:cNvPr>
          <p:cNvSpPr txBox="1"/>
          <p:nvPr/>
        </p:nvSpPr>
        <p:spPr>
          <a:xfrm>
            <a:off x="5124937" y="2662338"/>
            <a:ext cx="6222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50 µm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F5051C5B-897F-4B06-8D98-A20B3C150E61}"/>
              </a:ext>
            </a:extLst>
          </p:cNvPr>
          <p:cNvCxnSpPr>
            <a:cxnSpLocks/>
          </p:cNvCxnSpPr>
          <p:nvPr/>
        </p:nvCxnSpPr>
        <p:spPr>
          <a:xfrm>
            <a:off x="10692075" y="5569902"/>
            <a:ext cx="457200" cy="0"/>
          </a:xfrm>
          <a:prstGeom prst="line">
            <a:avLst/>
          </a:prstGeom>
          <a:ln w="222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BAF64993-1DC8-452A-B3A0-371FD31409C4}"/>
              </a:ext>
            </a:extLst>
          </p:cNvPr>
          <p:cNvSpPr txBox="1"/>
          <p:nvPr/>
        </p:nvSpPr>
        <p:spPr>
          <a:xfrm>
            <a:off x="5062190" y="5350417"/>
            <a:ext cx="6222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50 µm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A984D67-0AD9-4183-84B2-E458A3DA1641}"/>
              </a:ext>
            </a:extLst>
          </p:cNvPr>
          <p:cNvSpPr txBox="1"/>
          <p:nvPr/>
        </p:nvSpPr>
        <p:spPr>
          <a:xfrm>
            <a:off x="10565744" y="5286792"/>
            <a:ext cx="7072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 µm</a:t>
            </a:r>
          </a:p>
        </p:txBody>
      </p:sp>
    </p:spTree>
    <p:extLst>
      <p:ext uri="{BB962C8B-B14F-4D97-AF65-F5344CB8AC3E}">
        <p14:creationId xmlns:p14="http://schemas.microsoft.com/office/powerpoint/2010/main" val="4955650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30</TotalTime>
  <Words>119</Words>
  <Application>Microsoft Office PowerPoint</Application>
  <PresentationFormat>Widescreen</PresentationFormat>
  <Paragraphs>1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lorian Schlotter</dc:creator>
  <cp:lastModifiedBy>Josh Hutcheson</cp:lastModifiedBy>
  <cp:revision>3</cp:revision>
  <dcterms:created xsi:type="dcterms:W3CDTF">2021-04-27T07:45:53Z</dcterms:created>
  <dcterms:modified xsi:type="dcterms:W3CDTF">2021-04-30T18:11:45Z</dcterms:modified>
</cp:coreProperties>
</file>